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802" y="-42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4594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8961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349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2725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618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235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941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367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748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609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171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C048A-50DE-4A1D-87ED-38BE075F0067}" type="datetimeFigureOut">
              <a:rPr kumimoji="1" lang="ja-JP" altLang="en-US" smtClean="0"/>
              <a:t>2015/5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6E746-6B2A-47AA-A9CF-32061BC96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6097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0" descr="http://genome.ucsc.edu/trash/hgt/hgt_genome_42e_350000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017" y="314875"/>
            <a:ext cx="4179204" cy="57379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-1768343" y="-1122215"/>
            <a:ext cx="5219699" cy="369332"/>
          </a:xfrm>
          <a:prstGeom prst="rect">
            <a:avLst/>
          </a:prstGeom>
          <a:solidFill>
            <a:srgbClr val="FFC0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TCF binding patterns at the human beta-globin locus</a:t>
            </a:r>
            <a:endParaRPr kumimoji="1" lang="ja-JP" altLang="en-US" dirty="0"/>
          </a:p>
        </p:txBody>
      </p:sp>
      <p:sp>
        <p:nvSpPr>
          <p:cNvPr id="5" name="正方形/長方形 4"/>
          <p:cNvSpPr/>
          <p:nvPr/>
        </p:nvSpPr>
        <p:spPr>
          <a:xfrm>
            <a:off x="1351953" y="1356818"/>
            <a:ext cx="88652" cy="4762981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158572" y="685383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i="1" dirty="0" smtClean="0">
                <a:latin typeface="Arial Narrow" panose="020B0606020202030204" pitchFamily="34" charset="0"/>
              </a:rPr>
              <a:t>HBB</a:t>
            </a:r>
            <a:endParaRPr kumimoji="1" lang="ja-JP" altLang="en-US" sz="1050" b="1" i="1" dirty="0">
              <a:latin typeface="Arial Narrow" panose="020B060602020203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865944" y="-1757765"/>
            <a:ext cx="5079467" cy="369332"/>
          </a:xfrm>
          <a:prstGeom prst="rect">
            <a:avLst/>
          </a:prstGeom>
          <a:solidFill>
            <a:srgbClr val="FFC0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TCF binding patterns at the human CCNB1IP1 locus</a:t>
            </a:r>
            <a:endParaRPr kumimoji="1" lang="ja-JP" altLang="en-US" dirty="0"/>
          </a:p>
        </p:txBody>
      </p:sp>
      <p:sp>
        <p:nvSpPr>
          <p:cNvPr id="11" name="正方形/長方形 10"/>
          <p:cNvSpPr/>
          <p:nvPr/>
        </p:nvSpPr>
        <p:spPr>
          <a:xfrm>
            <a:off x="3136739" y="244487"/>
            <a:ext cx="1449516" cy="58861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7" name="Picture 2" descr="http://genome.ucsc.edu/trash/hgt/hgt_genome_386_34da80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4739" y="168187"/>
            <a:ext cx="2731625" cy="58962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正方形/長方形 11"/>
          <p:cNvSpPr/>
          <p:nvPr/>
        </p:nvSpPr>
        <p:spPr>
          <a:xfrm>
            <a:off x="4490636" y="1361897"/>
            <a:ext cx="111055" cy="4762981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866676" y="755228"/>
            <a:ext cx="7553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i="1" dirty="0" smtClean="0">
                <a:latin typeface="Arial Narrow" panose="020B0606020202030204" pitchFamily="34" charset="0"/>
              </a:rPr>
              <a:t>CCNB1IP1</a:t>
            </a:r>
            <a:endParaRPr kumimoji="1" lang="ja-JP" altLang="en-US" sz="1050" b="1" i="1" dirty="0">
              <a:latin typeface="Arial Narrow" panose="020B060602020203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366817" y="671359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i="1" dirty="0" smtClean="0">
                <a:latin typeface="Arial Narrow" panose="020B0606020202030204" pitchFamily="34" charset="0"/>
              </a:rPr>
              <a:t>PARP2</a:t>
            </a:r>
            <a:endParaRPr kumimoji="1" lang="ja-JP" altLang="en-US" sz="1050" b="1" i="1" dirty="0">
              <a:latin typeface="Arial Narrow" panose="020B0606020202030204" pitchFamily="34" charset="0"/>
            </a:endParaRPr>
          </a:p>
        </p:txBody>
      </p:sp>
      <p:cxnSp>
        <p:nvCxnSpPr>
          <p:cNvPr id="17" name="直線矢印コネクタ 16"/>
          <p:cNvCxnSpPr/>
          <p:nvPr/>
        </p:nvCxnSpPr>
        <p:spPr>
          <a:xfrm>
            <a:off x="5450646" y="920405"/>
            <a:ext cx="432000" cy="0"/>
          </a:xfrm>
          <a:prstGeom prst="straightConnector1">
            <a:avLst/>
          </a:prstGeom>
          <a:ln w="19050">
            <a:solidFill>
              <a:srgbClr val="0000FF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6" descr="http://genome.ucsc.edu/trash/hgt/hgt_genome_3f01_353980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7846" y="563246"/>
            <a:ext cx="3087740" cy="5507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正方形/長方形 19"/>
          <p:cNvSpPr/>
          <p:nvPr/>
        </p:nvSpPr>
        <p:spPr>
          <a:xfrm>
            <a:off x="7764608" y="1361900"/>
            <a:ext cx="111055" cy="4762981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二等辺三角形 20"/>
          <p:cNvSpPr/>
          <p:nvPr/>
        </p:nvSpPr>
        <p:spPr>
          <a:xfrm flipV="1">
            <a:off x="7777433" y="1258321"/>
            <a:ext cx="72000" cy="72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二等辺三角形 21"/>
          <p:cNvSpPr/>
          <p:nvPr/>
        </p:nvSpPr>
        <p:spPr>
          <a:xfrm flipV="1">
            <a:off x="4508551" y="1258321"/>
            <a:ext cx="72000" cy="72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二等辺三角形 22"/>
          <p:cNvSpPr/>
          <p:nvPr/>
        </p:nvSpPr>
        <p:spPr>
          <a:xfrm flipV="1">
            <a:off x="1359107" y="1250438"/>
            <a:ext cx="72000" cy="72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/>
          <p:cNvSpPr/>
          <p:nvPr/>
        </p:nvSpPr>
        <p:spPr>
          <a:xfrm>
            <a:off x="8686799" y="563246"/>
            <a:ext cx="445138" cy="56325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矢印コネクタ 24"/>
          <p:cNvCxnSpPr/>
          <p:nvPr/>
        </p:nvCxnSpPr>
        <p:spPr>
          <a:xfrm flipH="1">
            <a:off x="4084434" y="1000353"/>
            <a:ext cx="432000" cy="0"/>
          </a:xfrm>
          <a:prstGeom prst="straightConnector1">
            <a:avLst/>
          </a:prstGeom>
          <a:ln w="19050">
            <a:solidFill>
              <a:srgbClr val="0000FF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 flipH="1">
            <a:off x="7381433" y="1152753"/>
            <a:ext cx="432000" cy="0"/>
          </a:xfrm>
          <a:prstGeom prst="straightConnector1">
            <a:avLst/>
          </a:prstGeom>
          <a:ln w="19050">
            <a:solidFill>
              <a:srgbClr val="0000FF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7365291" y="1103597"/>
            <a:ext cx="4860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i="1" dirty="0" smtClean="0">
                <a:latin typeface="Arial Narrow" panose="020B0606020202030204" pitchFamily="34" charset="0"/>
              </a:rPr>
              <a:t>ANK1</a:t>
            </a:r>
            <a:endParaRPr kumimoji="1" lang="ja-JP" altLang="en-US" sz="1050" b="1" i="1" dirty="0">
              <a:latin typeface="Arial Narrow" panose="020B060602020203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1719" y="-16479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 Narrow" panose="020B0606020202030204" pitchFamily="34" charset="0"/>
              </a:rPr>
              <a:t>A</a:t>
            </a:r>
            <a:endParaRPr kumimoji="1" lang="ja-JP" altLang="en-US" b="1" dirty="0">
              <a:latin typeface="Arial Narrow" panose="020B060602020203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130434" y="-16479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 Narrow" panose="020B0606020202030204" pitchFamily="34" charset="0"/>
              </a:rPr>
              <a:t>B</a:t>
            </a:r>
            <a:endParaRPr kumimoji="1" lang="ja-JP" altLang="en-US" b="1" dirty="0">
              <a:latin typeface="Arial Narrow" panose="020B060602020203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004782" y="-16479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 Narrow" panose="020B0606020202030204" pitchFamily="34" charset="0"/>
              </a:rPr>
              <a:t>C</a:t>
            </a:r>
            <a:endParaRPr kumimoji="1" lang="ja-JP" altLang="en-US" b="1" dirty="0">
              <a:latin typeface="Arial Narrow" panose="020B060602020203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271666" y="152397"/>
            <a:ext cx="447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Arial Narrow" panose="020B0606020202030204" pitchFamily="34" charset="0"/>
              </a:rPr>
              <a:t>20kb</a:t>
            </a:r>
            <a:endParaRPr kumimoji="1" lang="ja-JP" altLang="en-US" sz="1100" b="1" dirty="0">
              <a:latin typeface="Arial Narrow" panose="020B060602020203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554171" y="157880"/>
            <a:ext cx="447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Arial Narrow" panose="020B0606020202030204" pitchFamily="34" charset="0"/>
              </a:rPr>
              <a:t>10kb</a:t>
            </a:r>
            <a:endParaRPr kumimoji="1" lang="ja-JP" altLang="en-US" sz="1100" b="1" dirty="0">
              <a:latin typeface="Arial Narrow" panose="020B060602020203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7605696" y="400979"/>
            <a:ext cx="447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Arial Narrow" panose="020B0606020202030204" pitchFamily="34" charset="0"/>
              </a:rPr>
              <a:t>50kb</a:t>
            </a:r>
            <a:endParaRPr kumimoji="1" lang="ja-JP" altLang="en-US" sz="1100" b="1" dirty="0">
              <a:latin typeface="Arial Narrow" panose="020B060602020203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5496" y="6165304"/>
            <a:ext cx="909919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 Fig. Occupancy patterns of CTCF at </a:t>
            </a:r>
            <a:r>
              <a:rPr kumimoji="1" lang="en-US" altLang="ja-JP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BB </a:t>
            </a:r>
            <a:r>
              <a:rPr kumimoji="1"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, </a:t>
            </a:r>
            <a:r>
              <a:rPr kumimoji="1" lang="en-US" altLang="ja-JP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NB1IP1-PARP2 </a:t>
            </a:r>
            <a:r>
              <a:rPr kumimoji="1"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, and </a:t>
            </a:r>
            <a:r>
              <a:rPr kumimoji="1" lang="en-US" altLang="ja-JP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K1</a:t>
            </a:r>
            <a:r>
              <a:rPr kumimoji="1"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loci in various cell lines</a:t>
            </a:r>
          </a:p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CF </a:t>
            </a:r>
            <a:r>
              <a:rPr lang="en-US" altLang="ja-JP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P-seq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from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ENCODE project (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ttps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//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e.ucsc.edu/ENCODE/index.html)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shown. Red rectangles indicate the location of an insulator for each locus: 5’HS4 insulator at </a:t>
            </a:r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BB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ocus,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utative </a:t>
            </a:r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NB1IP1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insulator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K1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sulator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18]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reas CTCF peaks were observed in the majority of the cell lines at 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5’HS4 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ulator, no peaks were observed at </a:t>
            </a:r>
            <a:r>
              <a:rPr kumimoji="1"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NB1IP1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kumimoji="1"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K1</a:t>
            </a:r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sulators.  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9228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119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N2012B</dc:creator>
  <cp:lastModifiedBy>KN2012B</cp:lastModifiedBy>
  <cp:revision>4</cp:revision>
  <dcterms:created xsi:type="dcterms:W3CDTF">2015-04-28T21:16:05Z</dcterms:created>
  <dcterms:modified xsi:type="dcterms:W3CDTF">2015-05-01T02:10:45Z</dcterms:modified>
</cp:coreProperties>
</file>